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D17BF1-9492-4DA0-A098-0B392D98883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EB8A75-58B1-4385-BFDF-103B767FFB6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59A99E-D185-4399-BC84-2B85AC59333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59914F-264E-4F69-93EF-C3B1ECD30C6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DA68A0-6825-45D6-8E72-E132F469CE4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C5BBE1-14AA-42C5-A9C1-705B1F76D0C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025460-2E21-488F-AD01-D4D24E69220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B12696-A147-4DBD-AA25-33C320B1723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C0465A-3314-42D8-A1C3-BEA33719156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69BB49-6CB1-45A6-8FD8-84C9E90DA8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487125-153D-46FB-AC89-ABDAA545950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9FD03A-34CA-4656-BF9E-A882D88D7E8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4CD4532-3D3F-4E3F-B838-F2B2D064569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44280" y="8121600"/>
            <a:ext cx="6740640" cy="1554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dditional file 3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ot plots of xenoarray analysis on the 34 probes reported in Table 1. The plots compare the enrichment driven by polyhema selection (x-axis) with the enrichment driven by serum withdrawal (A) or transwell “diving” (B). Selection by serum withdrawal was performed by incubating cells in medium without serum for 4 weeks. Transwell “diving” selection was performed by plating cells on 24mm transwell filters (Costar) mounted on 6-well plates. After 3 weeks, cells spontaneously detached from the bottom of the filter and grown on the underlying well were recovered and replated on transwell filters for a second round of selection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1341360" y="0"/>
            <a:ext cx="4559400" cy="3583080"/>
          </a:xfrm>
          <a:prstGeom prst="rect">
            <a:avLst/>
          </a:prstGeom>
          <a:ln w="0">
            <a:noFill/>
          </a:ln>
        </p:spPr>
      </p:pic>
      <p:sp>
        <p:nvSpPr>
          <p:cNvPr id="43" name=""/>
          <p:cNvSpPr/>
          <p:nvPr/>
        </p:nvSpPr>
        <p:spPr>
          <a:xfrm>
            <a:off x="1782720" y="3456000"/>
            <a:ext cx="3983040" cy="337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old enrichment by polyhema selectio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 rot="16200000">
            <a:off x="35280" y="1406880"/>
            <a:ext cx="2183400" cy="5806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old enrichment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by serum withdrawa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838800" y="8748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" descr=""/>
          <p:cNvPicPr/>
          <p:nvPr/>
        </p:nvPicPr>
        <p:blipFill>
          <a:blip r:embed="rId2"/>
          <a:stretch/>
        </p:blipFill>
        <p:spPr>
          <a:xfrm>
            <a:off x="1341360" y="4089240"/>
            <a:ext cx="4516560" cy="3633840"/>
          </a:xfrm>
          <a:prstGeom prst="rect">
            <a:avLst/>
          </a:prstGeom>
          <a:ln w="0">
            <a:noFill/>
          </a:ln>
        </p:spPr>
      </p:pic>
      <p:sp>
        <p:nvSpPr>
          <p:cNvPr id="47" name=""/>
          <p:cNvSpPr/>
          <p:nvPr/>
        </p:nvSpPr>
        <p:spPr>
          <a:xfrm>
            <a:off x="1782720" y="7529400"/>
            <a:ext cx="3983040" cy="337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old enrichment by polyhema selectio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 rot="16200000">
            <a:off x="23040" y="5613120"/>
            <a:ext cx="2207520" cy="5806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old enrichment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by transwell “diving”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838800" y="416232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1-30T13:44:08Z</dcterms:created>
  <dc:creator>emedico</dc:creator>
  <dc:description/>
  <dc:language>en-US</dc:language>
  <cp:lastModifiedBy>emedico</cp:lastModifiedBy>
  <dcterms:modified xsi:type="dcterms:W3CDTF">2008-05-29T13:04:31Z</dcterms:modified>
  <cp:revision>8</cp:revision>
  <dc:subject/>
  <dc:title>Slide 1</dc:title>
</cp:coreProperties>
</file>